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33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F7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1" autoAdjust="0"/>
    <p:restoredTop sz="95681" autoAdjust="0"/>
  </p:normalViewPr>
  <p:slideViewPr>
    <p:cSldViewPr snapToGrid="0">
      <p:cViewPr>
        <p:scale>
          <a:sx n="172" d="100"/>
          <a:sy n="172" d="100"/>
        </p:scale>
        <p:origin x="412" y="-180"/>
      </p:cViewPr>
      <p:guideLst>
        <p:guide orient="horz" pos="2608"/>
        <p:guide pos="33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7394F4-61EA-4CA6-AC3A-DCC80DD851E8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9175" y="1143000"/>
            <a:ext cx="2279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99B2A-D5B8-40D7-9094-C73879A2DE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414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4146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35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036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1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26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97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386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306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50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27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874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221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>
            <a:extLst>
              <a:ext uri="{FF2B5EF4-FFF2-40B4-BE49-F238E27FC236}">
                <a16:creationId xmlns:a16="http://schemas.microsoft.com/office/drawing/2014/main" id="{44C4440F-46E2-4CFA-BE19-6DA3090DCF9F}"/>
              </a:ext>
            </a:extLst>
          </p:cNvPr>
          <p:cNvGrpSpPr/>
          <p:nvPr/>
        </p:nvGrpSpPr>
        <p:grpSpPr>
          <a:xfrm>
            <a:off x="355600" y="1759802"/>
            <a:ext cx="1991637" cy="2524330"/>
            <a:chOff x="6632949" y="691474"/>
            <a:chExt cx="3190175" cy="4133493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C87D0085-D0AD-4551-B8C4-227ACB210C8C}"/>
                </a:ext>
              </a:extLst>
            </p:cNvPr>
            <p:cNvGrpSpPr/>
            <p:nvPr/>
          </p:nvGrpSpPr>
          <p:grpSpPr>
            <a:xfrm>
              <a:off x="6632949" y="691474"/>
              <a:ext cx="3190175" cy="3681845"/>
              <a:chOff x="1879419" y="832497"/>
              <a:chExt cx="3190175" cy="3681845"/>
            </a:xfrm>
          </p:grpSpPr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3131F4E9-D335-4C2A-BF5F-33ADD516B6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4445" y="2629726"/>
                <a:ext cx="1826834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E749CF9C-BBD1-4145-AF4C-197EB289D7A1}"/>
                  </a:ext>
                </a:extLst>
              </p:cNvPr>
              <p:cNvSpPr txBox="1"/>
              <p:nvPr/>
            </p:nvSpPr>
            <p:spPr>
              <a:xfrm rot="18791615">
                <a:off x="2597105" y="1685589"/>
                <a:ext cx="1774928" cy="295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mics NC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FC6DCE95-6C13-4DA8-9E9B-A221855D20FE}"/>
                  </a:ext>
                </a:extLst>
              </p:cNvPr>
              <p:cNvSpPr txBox="1"/>
              <p:nvPr/>
            </p:nvSpPr>
            <p:spPr>
              <a:xfrm rot="18753308">
                <a:off x="3132932" y="1767192"/>
                <a:ext cx="1559690" cy="295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mics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554CB87-DE0E-4E16-A4B1-845CD2B391D6}"/>
                  </a:ext>
                </a:extLst>
              </p:cNvPr>
              <p:cNvSpPr txBox="1"/>
              <p:nvPr/>
            </p:nvSpPr>
            <p:spPr>
              <a:xfrm rot="18749775">
                <a:off x="3597880" y="1617998"/>
                <a:ext cx="1866798" cy="295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hibitor NC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DD3CB49A-4E20-404E-BF75-712BFE084A46}"/>
                  </a:ext>
                </a:extLst>
              </p:cNvPr>
              <p:cNvSpPr txBox="1"/>
              <p:nvPr/>
            </p:nvSpPr>
            <p:spPr>
              <a:xfrm rot="18816844">
                <a:off x="4095918" y="1728291"/>
                <a:ext cx="1651558" cy="295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hibitor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B4E083B9-A66C-4F6B-93F1-C66B2A2D42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236" t="25467" r="34722" b="61983"/>
              <a:stretch/>
            </p:blipFill>
            <p:spPr>
              <a:xfrm>
                <a:off x="2746021" y="2758253"/>
                <a:ext cx="1785257" cy="347851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0EB696D8-373A-4234-8D3E-AAA44E4EA7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13" t="47637" r="60563" b="39114"/>
              <a:stretch/>
            </p:blipFill>
            <p:spPr>
              <a:xfrm>
                <a:off x="2743396" y="4135750"/>
                <a:ext cx="1785257" cy="347852"/>
              </a:xfrm>
              <a:prstGeom prst="rect">
                <a:avLst/>
              </a:prstGeom>
            </p:spPr>
          </p:pic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A835FF92-A6EB-4C9D-ACD1-2C633C369AC4}"/>
                  </a:ext>
                </a:extLst>
              </p:cNvPr>
              <p:cNvSpPr txBox="1"/>
              <p:nvPr/>
            </p:nvSpPr>
            <p:spPr>
              <a:xfrm>
                <a:off x="1882044" y="2770165"/>
                <a:ext cx="1087676" cy="352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3K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ED2CA246-43A8-43EE-A480-3B81795CFB90}"/>
                  </a:ext>
                </a:extLst>
              </p:cNvPr>
              <p:cNvSpPr txBox="1"/>
              <p:nvPr/>
            </p:nvSpPr>
            <p:spPr>
              <a:xfrm>
                <a:off x="1879419" y="4161561"/>
                <a:ext cx="1087676" cy="352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3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D6DB7365-1233-495C-8292-C902D23B82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01" t="49106" r="64872" b="36640"/>
            <a:stretch/>
          </p:blipFill>
          <p:spPr>
            <a:xfrm>
              <a:off x="7499550" y="4482067"/>
              <a:ext cx="1785255" cy="342900"/>
            </a:xfrm>
            <a:prstGeom prst="rect">
              <a:avLst/>
            </a:prstGeom>
          </p:spPr>
        </p:pic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D489F86F-57FD-47FF-B3CE-69BA1938426C}"/>
                </a:ext>
              </a:extLst>
            </p:cNvPr>
            <p:cNvSpPr txBox="1"/>
            <p:nvPr/>
          </p:nvSpPr>
          <p:spPr>
            <a:xfrm>
              <a:off x="6632949" y="4469775"/>
              <a:ext cx="1005777" cy="352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EDDFDD39-8BE2-48FC-AD83-60D5909BC284}"/>
                </a:ext>
              </a:extLst>
            </p:cNvPr>
            <p:cNvSpPr txBox="1"/>
            <p:nvPr/>
          </p:nvSpPr>
          <p:spPr>
            <a:xfrm>
              <a:off x="6632949" y="3564660"/>
              <a:ext cx="1005777" cy="352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4234E7FF-F003-4874-BE2B-C6FDFCD2F6E1}"/>
                </a:ext>
              </a:extLst>
            </p:cNvPr>
            <p:cNvSpPr txBox="1"/>
            <p:nvPr/>
          </p:nvSpPr>
          <p:spPr>
            <a:xfrm>
              <a:off x="6632949" y="3082642"/>
              <a:ext cx="1005777" cy="352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E74E8006-F8D7-4783-AFAC-A93EEB98FD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95" t="36057" r="17678" b="47334"/>
            <a:stretch/>
          </p:blipFill>
          <p:spPr>
            <a:xfrm>
              <a:off x="7499551" y="3524631"/>
              <a:ext cx="1785257" cy="342900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5044ECCC-DAFC-443A-9585-F056F20B5F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45" t="38293" r="31589" b="42273"/>
            <a:stretch/>
          </p:blipFill>
          <p:spPr>
            <a:xfrm>
              <a:off x="7499551" y="3077734"/>
              <a:ext cx="1785255" cy="342901"/>
            </a:xfrm>
            <a:prstGeom prst="rect">
              <a:avLst/>
            </a:prstGeom>
          </p:spPr>
        </p:pic>
      </p:grpSp>
      <p:sp>
        <p:nvSpPr>
          <p:cNvPr id="47" name="文本框 46">
            <a:extLst>
              <a:ext uri="{FF2B5EF4-FFF2-40B4-BE49-F238E27FC236}">
                <a16:creationId xmlns:a16="http://schemas.microsoft.com/office/drawing/2014/main" id="{82F22304-015D-4935-8D8D-69CEBBBCD19B}"/>
              </a:ext>
            </a:extLst>
          </p:cNvPr>
          <p:cNvSpPr txBox="1"/>
          <p:nvPr/>
        </p:nvSpPr>
        <p:spPr>
          <a:xfrm>
            <a:off x="348668" y="1879115"/>
            <a:ext cx="685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666ED0C4-0FA3-43F8-878E-2EA7A7128E1E}"/>
              </a:ext>
            </a:extLst>
          </p:cNvPr>
          <p:cNvCxnSpPr>
            <a:cxnSpLocks/>
          </p:cNvCxnSpPr>
          <p:nvPr/>
        </p:nvCxnSpPr>
        <p:spPr>
          <a:xfrm>
            <a:off x="3788821" y="1370521"/>
            <a:ext cx="12125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706194B7-B905-4812-B080-2C7C4E0EA45A}"/>
              </a:ext>
            </a:extLst>
          </p:cNvPr>
          <p:cNvSpPr txBox="1"/>
          <p:nvPr/>
        </p:nvSpPr>
        <p:spPr>
          <a:xfrm rot="18791615">
            <a:off x="3687692" y="742007"/>
            <a:ext cx="12378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6523E0C-E957-4734-A703-BA52D2B449C5}"/>
              </a:ext>
            </a:extLst>
          </p:cNvPr>
          <p:cNvSpPr txBox="1"/>
          <p:nvPr/>
        </p:nvSpPr>
        <p:spPr>
          <a:xfrm rot="18753308">
            <a:off x="4047249" y="796172"/>
            <a:ext cx="10871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2F073E6-5A5F-4657-A6F9-6E5A3BDC6101}"/>
              </a:ext>
            </a:extLst>
          </p:cNvPr>
          <p:cNvSpPr txBox="1"/>
          <p:nvPr/>
        </p:nvSpPr>
        <p:spPr>
          <a:xfrm rot="18749775">
            <a:off x="4350358" y="697146"/>
            <a:ext cx="13019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N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BB8369F-A107-4FF2-B8BA-D47DA7EE09C7}"/>
              </a:ext>
            </a:extLst>
          </p:cNvPr>
          <p:cNvSpPr txBox="1"/>
          <p:nvPr/>
        </p:nvSpPr>
        <p:spPr>
          <a:xfrm rot="18816844">
            <a:off x="4684835" y="770353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F5ED757B-B89E-4316-BA1B-EC3A642E33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52" t="12103" r="33916" b="33415"/>
          <a:stretch/>
        </p:blipFill>
        <p:spPr>
          <a:xfrm>
            <a:off x="3772753" y="1458980"/>
            <a:ext cx="1228588" cy="948644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C42759B5-B792-42E7-9ACB-1F5707061825}"/>
              </a:ext>
            </a:extLst>
          </p:cNvPr>
          <p:cNvSpPr txBox="1"/>
          <p:nvPr/>
        </p:nvSpPr>
        <p:spPr>
          <a:xfrm>
            <a:off x="2009526" y="2906592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2D10DEF-4451-4A74-AA2F-90EA5F300595}"/>
              </a:ext>
            </a:extLst>
          </p:cNvPr>
          <p:cNvSpPr txBox="1"/>
          <p:nvPr/>
        </p:nvSpPr>
        <p:spPr>
          <a:xfrm>
            <a:off x="2007544" y="318028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B5714B25-018D-490F-8CFB-BE841098F64E}"/>
              </a:ext>
            </a:extLst>
          </p:cNvPr>
          <p:cNvSpPr txBox="1"/>
          <p:nvPr/>
        </p:nvSpPr>
        <p:spPr>
          <a:xfrm>
            <a:off x="2016699" y="347869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124783E1-4C29-497A-8413-798513576BF1}"/>
              </a:ext>
            </a:extLst>
          </p:cNvPr>
          <p:cNvSpPr txBox="1"/>
          <p:nvPr/>
        </p:nvSpPr>
        <p:spPr>
          <a:xfrm>
            <a:off x="2016699" y="3755894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147CCAD5-C176-438E-9877-EA88FB80345D}"/>
              </a:ext>
            </a:extLst>
          </p:cNvPr>
          <p:cNvSpPr txBox="1"/>
          <p:nvPr/>
        </p:nvSpPr>
        <p:spPr>
          <a:xfrm>
            <a:off x="2016699" y="4062290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1F6AA580-E442-468E-85A5-C53787C2BD56}"/>
              </a:ext>
            </a:extLst>
          </p:cNvPr>
          <p:cNvGrpSpPr/>
          <p:nvPr/>
        </p:nvGrpSpPr>
        <p:grpSpPr>
          <a:xfrm>
            <a:off x="5186022" y="1520639"/>
            <a:ext cx="838621" cy="246221"/>
            <a:chOff x="4270597" y="2352943"/>
            <a:chExt cx="838621" cy="246221"/>
          </a:xfrm>
        </p:grpSpPr>
        <p:cxnSp>
          <p:nvCxnSpPr>
            <p:cNvPr id="64" name="直接箭头连接符 63">
              <a:extLst>
                <a:ext uri="{FF2B5EF4-FFF2-40B4-BE49-F238E27FC236}">
                  <a16:creationId xmlns:a16="http://schemas.microsoft.com/office/drawing/2014/main" id="{4937E36F-57AE-4A16-976D-D045C0653D8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7ECDEC97-BF43-47FB-A618-4C186F41F9F5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A8ED1A57-926F-441D-B2D1-93A74ABADF6C}"/>
              </a:ext>
            </a:extLst>
          </p:cNvPr>
          <p:cNvGrpSpPr/>
          <p:nvPr/>
        </p:nvGrpSpPr>
        <p:grpSpPr>
          <a:xfrm>
            <a:off x="5196586" y="1822844"/>
            <a:ext cx="774500" cy="246221"/>
            <a:chOff x="4422997" y="2505343"/>
            <a:chExt cx="774500" cy="246221"/>
          </a:xfrm>
        </p:grpSpPr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002B34E4-AF2B-42AF-AD87-F75353CA460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29F8F45-854C-480E-B480-24FADF97F513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6" name="图片 15">
            <a:extLst>
              <a:ext uri="{FF2B5EF4-FFF2-40B4-BE49-F238E27FC236}">
                <a16:creationId xmlns:a16="http://schemas.microsoft.com/office/drawing/2014/main" id="{C7EE065F-197D-465D-8BC0-3F933D2491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19" t="15751" r="30794" b="17956"/>
          <a:stretch/>
        </p:blipFill>
        <p:spPr>
          <a:xfrm>
            <a:off x="3772753" y="2473035"/>
            <a:ext cx="1228588" cy="912690"/>
          </a:xfrm>
          <a:prstGeom prst="rect">
            <a:avLst/>
          </a:prstGeom>
        </p:spPr>
      </p:pic>
      <p:grpSp>
        <p:nvGrpSpPr>
          <p:cNvPr id="69" name="组合 68">
            <a:extLst>
              <a:ext uri="{FF2B5EF4-FFF2-40B4-BE49-F238E27FC236}">
                <a16:creationId xmlns:a16="http://schemas.microsoft.com/office/drawing/2014/main" id="{D1D35E4C-0B20-468C-8ECA-E2E5A8779B98}"/>
              </a:ext>
            </a:extLst>
          </p:cNvPr>
          <p:cNvGrpSpPr/>
          <p:nvPr/>
        </p:nvGrpSpPr>
        <p:grpSpPr>
          <a:xfrm>
            <a:off x="5223145" y="2640934"/>
            <a:ext cx="774500" cy="246221"/>
            <a:chOff x="4270597" y="2352943"/>
            <a:chExt cx="774500" cy="246221"/>
          </a:xfrm>
        </p:grpSpPr>
        <p:cxnSp>
          <p:nvCxnSpPr>
            <p:cNvPr id="70" name="直接箭头连接符 69">
              <a:extLst>
                <a:ext uri="{FF2B5EF4-FFF2-40B4-BE49-F238E27FC236}">
                  <a16:creationId xmlns:a16="http://schemas.microsoft.com/office/drawing/2014/main" id="{5096E1FF-8F90-48DF-ADE1-92E57934089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E843E66B-AEE7-4784-8467-FA95AA122031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A848B443-7E0A-41A6-80F9-197566BADDC0}"/>
              </a:ext>
            </a:extLst>
          </p:cNvPr>
          <p:cNvGrpSpPr/>
          <p:nvPr/>
        </p:nvGrpSpPr>
        <p:grpSpPr>
          <a:xfrm>
            <a:off x="5222412" y="2878347"/>
            <a:ext cx="774500" cy="246221"/>
            <a:chOff x="4422997" y="2505343"/>
            <a:chExt cx="774500" cy="246221"/>
          </a:xfrm>
        </p:grpSpPr>
        <p:cxnSp>
          <p:nvCxnSpPr>
            <p:cNvPr id="73" name="直接箭头连接符 72">
              <a:extLst>
                <a:ext uri="{FF2B5EF4-FFF2-40B4-BE49-F238E27FC236}">
                  <a16:creationId xmlns:a16="http://schemas.microsoft.com/office/drawing/2014/main" id="{706093B0-0B3B-49EA-918C-7ECA7EBBF7D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1741CC88-AF32-4EDC-8272-E50A9FAD34A7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8" name="图片 17">
            <a:extLst>
              <a:ext uri="{FF2B5EF4-FFF2-40B4-BE49-F238E27FC236}">
                <a16:creationId xmlns:a16="http://schemas.microsoft.com/office/drawing/2014/main" id="{8E9E3A75-788D-4BB8-B03A-432A156901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33" t="37010" r="11076" b="24023"/>
          <a:stretch/>
        </p:blipFill>
        <p:spPr>
          <a:xfrm>
            <a:off x="3772753" y="3562573"/>
            <a:ext cx="1228588" cy="644960"/>
          </a:xfrm>
          <a:prstGeom prst="rect">
            <a:avLst/>
          </a:prstGeom>
        </p:spPr>
      </p:pic>
      <p:grpSp>
        <p:nvGrpSpPr>
          <p:cNvPr id="75" name="组合 74">
            <a:extLst>
              <a:ext uri="{FF2B5EF4-FFF2-40B4-BE49-F238E27FC236}">
                <a16:creationId xmlns:a16="http://schemas.microsoft.com/office/drawing/2014/main" id="{20E54293-F5B7-4566-9CE4-A57C43E0A2D5}"/>
              </a:ext>
            </a:extLst>
          </p:cNvPr>
          <p:cNvGrpSpPr/>
          <p:nvPr/>
        </p:nvGrpSpPr>
        <p:grpSpPr>
          <a:xfrm>
            <a:off x="5232455" y="3395370"/>
            <a:ext cx="774500" cy="246221"/>
            <a:chOff x="4270597" y="2352943"/>
            <a:chExt cx="774500" cy="246221"/>
          </a:xfrm>
        </p:grpSpPr>
        <p:cxnSp>
          <p:nvCxnSpPr>
            <p:cNvPr id="76" name="直接箭头连接符 75">
              <a:extLst>
                <a:ext uri="{FF2B5EF4-FFF2-40B4-BE49-F238E27FC236}">
                  <a16:creationId xmlns:a16="http://schemas.microsoft.com/office/drawing/2014/main" id="{E835B196-A50A-4C5E-8FBE-8CC817F70F1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FDB045CC-01F2-4BE0-827F-8791CD8DF3C4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F2DC5DCA-4272-456F-B3FB-6D8C2A9AFE77}"/>
              </a:ext>
            </a:extLst>
          </p:cNvPr>
          <p:cNvGrpSpPr/>
          <p:nvPr/>
        </p:nvGrpSpPr>
        <p:grpSpPr>
          <a:xfrm>
            <a:off x="5231722" y="3632783"/>
            <a:ext cx="774500" cy="246221"/>
            <a:chOff x="4422997" y="2505343"/>
            <a:chExt cx="774500" cy="246221"/>
          </a:xfrm>
        </p:grpSpPr>
        <p:cxnSp>
          <p:nvCxnSpPr>
            <p:cNvPr id="79" name="直接箭头连接符 78">
              <a:extLst>
                <a:ext uri="{FF2B5EF4-FFF2-40B4-BE49-F238E27FC236}">
                  <a16:creationId xmlns:a16="http://schemas.microsoft.com/office/drawing/2014/main" id="{52D9F437-F960-48BC-8BDF-DB234A4D47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1E255CF3-AC4F-4339-9B5F-54318059B1B5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2" name="图片 21">
            <a:extLst>
              <a:ext uri="{FF2B5EF4-FFF2-40B4-BE49-F238E27FC236}">
                <a16:creationId xmlns:a16="http://schemas.microsoft.com/office/drawing/2014/main" id="{8D2A80C8-B09D-4FB8-AA42-074253BB83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4" t="36972" r="64549" b="29313"/>
          <a:stretch/>
        </p:blipFill>
        <p:spPr>
          <a:xfrm>
            <a:off x="3772753" y="5340598"/>
            <a:ext cx="1228588" cy="766425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46A10E63-F074-4D2B-9AF9-DB8D834D589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7" t="22400" r="60619" b="16576"/>
          <a:stretch/>
        </p:blipFill>
        <p:spPr>
          <a:xfrm>
            <a:off x="3772753" y="4282660"/>
            <a:ext cx="1228588" cy="903031"/>
          </a:xfrm>
          <a:prstGeom prst="rect">
            <a:avLst/>
          </a:prstGeom>
        </p:spPr>
      </p:pic>
      <p:grpSp>
        <p:nvGrpSpPr>
          <p:cNvPr id="83" name="组合 82">
            <a:extLst>
              <a:ext uri="{FF2B5EF4-FFF2-40B4-BE49-F238E27FC236}">
                <a16:creationId xmlns:a16="http://schemas.microsoft.com/office/drawing/2014/main" id="{6192FFC3-A89A-4F0B-A90E-BFB4EE02412E}"/>
              </a:ext>
            </a:extLst>
          </p:cNvPr>
          <p:cNvGrpSpPr/>
          <p:nvPr/>
        </p:nvGrpSpPr>
        <p:grpSpPr>
          <a:xfrm>
            <a:off x="5235870" y="4264108"/>
            <a:ext cx="774500" cy="246221"/>
            <a:chOff x="4270597" y="2352943"/>
            <a:chExt cx="774500" cy="246221"/>
          </a:xfrm>
        </p:grpSpPr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07468BBC-AD6B-441A-ACEE-EEA56CF420D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4571329B-940F-4744-B45B-38F5C5315EAB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A0C8132C-5D46-4329-A821-2EDE5FE7A0F2}"/>
              </a:ext>
            </a:extLst>
          </p:cNvPr>
          <p:cNvGrpSpPr/>
          <p:nvPr/>
        </p:nvGrpSpPr>
        <p:grpSpPr>
          <a:xfrm>
            <a:off x="5235137" y="4501521"/>
            <a:ext cx="774500" cy="246221"/>
            <a:chOff x="4422997" y="2505343"/>
            <a:chExt cx="774500" cy="246221"/>
          </a:xfrm>
        </p:grpSpPr>
        <p:cxnSp>
          <p:nvCxnSpPr>
            <p:cNvPr id="87" name="直接箭头连接符 86">
              <a:extLst>
                <a:ext uri="{FF2B5EF4-FFF2-40B4-BE49-F238E27FC236}">
                  <a16:creationId xmlns:a16="http://schemas.microsoft.com/office/drawing/2014/main" id="{24C2B815-010E-49E2-BFE2-9989BD58DDF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E5EA8D64-478E-422E-8F26-08B448F3AE62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E19CD280-C49C-485D-801A-68C0E2419553}"/>
              </a:ext>
            </a:extLst>
          </p:cNvPr>
          <p:cNvGrpSpPr/>
          <p:nvPr/>
        </p:nvGrpSpPr>
        <p:grpSpPr>
          <a:xfrm>
            <a:off x="5231722" y="4756551"/>
            <a:ext cx="774500" cy="246221"/>
            <a:chOff x="4270597" y="2352943"/>
            <a:chExt cx="774500" cy="246221"/>
          </a:xfrm>
        </p:grpSpPr>
        <p:cxnSp>
          <p:nvCxnSpPr>
            <p:cNvPr id="90" name="直接箭头连接符 89">
              <a:extLst>
                <a:ext uri="{FF2B5EF4-FFF2-40B4-BE49-F238E27FC236}">
                  <a16:creationId xmlns:a16="http://schemas.microsoft.com/office/drawing/2014/main" id="{AFDE27BB-AD3B-499F-8AF5-B6DF38A5FCF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8D888E8F-9366-4492-B742-B6A6AD917B6C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D3311D30-917D-41B0-9D3A-EE2C27CA3AA8}"/>
              </a:ext>
            </a:extLst>
          </p:cNvPr>
          <p:cNvGrpSpPr/>
          <p:nvPr/>
        </p:nvGrpSpPr>
        <p:grpSpPr>
          <a:xfrm>
            <a:off x="5231722" y="5509552"/>
            <a:ext cx="774500" cy="246221"/>
            <a:chOff x="4270597" y="2352943"/>
            <a:chExt cx="774500" cy="246221"/>
          </a:xfrm>
        </p:grpSpPr>
        <p:cxnSp>
          <p:nvCxnSpPr>
            <p:cNvPr id="93" name="直接箭头连接符 92">
              <a:extLst>
                <a:ext uri="{FF2B5EF4-FFF2-40B4-BE49-F238E27FC236}">
                  <a16:creationId xmlns:a16="http://schemas.microsoft.com/office/drawing/2014/main" id="{289CBF6C-6E79-4A86-96AF-0A5EE6EED49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B593E670-AA39-4D75-A295-17AB0E99FA55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15C0C4E2-CA73-4A90-945E-78560FD6A742}"/>
              </a:ext>
            </a:extLst>
          </p:cNvPr>
          <p:cNvGrpSpPr/>
          <p:nvPr/>
        </p:nvGrpSpPr>
        <p:grpSpPr>
          <a:xfrm>
            <a:off x="5242286" y="5811757"/>
            <a:ext cx="774500" cy="246221"/>
            <a:chOff x="4422997" y="2505343"/>
            <a:chExt cx="774500" cy="246221"/>
          </a:xfrm>
        </p:grpSpPr>
        <p:cxnSp>
          <p:nvCxnSpPr>
            <p:cNvPr id="96" name="直接箭头连接符 95">
              <a:extLst>
                <a:ext uri="{FF2B5EF4-FFF2-40B4-BE49-F238E27FC236}">
                  <a16:creationId xmlns:a16="http://schemas.microsoft.com/office/drawing/2014/main" id="{1D263F96-6D4A-4BE3-A5C2-ABAF41FE4A7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2111EF9B-0F6D-4499-82D9-698C92C13387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8" name="文本框 97">
            <a:extLst>
              <a:ext uri="{FF2B5EF4-FFF2-40B4-BE49-F238E27FC236}">
                <a16:creationId xmlns:a16="http://schemas.microsoft.com/office/drawing/2014/main" id="{8CB5B5F1-6C71-43D6-9BEB-4F5EDD850C50}"/>
              </a:ext>
            </a:extLst>
          </p:cNvPr>
          <p:cNvSpPr txBox="1"/>
          <p:nvPr/>
        </p:nvSpPr>
        <p:spPr>
          <a:xfrm>
            <a:off x="3308692" y="1817886"/>
            <a:ext cx="6790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3K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E3B00591-8BC1-4E52-B2E8-CC10CCFE9FD3}"/>
              </a:ext>
            </a:extLst>
          </p:cNvPr>
          <p:cNvSpPr txBox="1"/>
          <p:nvPr/>
        </p:nvSpPr>
        <p:spPr>
          <a:xfrm>
            <a:off x="3341682" y="4663313"/>
            <a:ext cx="6790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91B4F5EF-ED5C-490C-A143-500162DD9602}"/>
              </a:ext>
            </a:extLst>
          </p:cNvPr>
          <p:cNvSpPr txBox="1"/>
          <p:nvPr/>
        </p:nvSpPr>
        <p:spPr>
          <a:xfrm>
            <a:off x="3217853" y="5641471"/>
            <a:ext cx="627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64B2E530-9F5D-4B31-914D-A436A3F8D47F}"/>
              </a:ext>
            </a:extLst>
          </p:cNvPr>
          <p:cNvSpPr txBox="1"/>
          <p:nvPr/>
        </p:nvSpPr>
        <p:spPr>
          <a:xfrm>
            <a:off x="3301100" y="3764702"/>
            <a:ext cx="627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CB6E64AB-B35F-4B03-A943-080C98C58FFF}"/>
              </a:ext>
            </a:extLst>
          </p:cNvPr>
          <p:cNvSpPr txBox="1"/>
          <p:nvPr/>
        </p:nvSpPr>
        <p:spPr>
          <a:xfrm>
            <a:off x="3276930" y="2827723"/>
            <a:ext cx="627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直接箭头连接符 102">
            <a:extLst>
              <a:ext uri="{FF2B5EF4-FFF2-40B4-BE49-F238E27FC236}">
                <a16:creationId xmlns:a16="http://schemas.microsoft.com/office/drawing/2014/main" id="{231CA521-420F-4019-93BC-BD121C8504EE}"/>
              </a:ext>
            </a:extLst>
          </p:cNvPr>
          <p:cNvCxnSpPr>
            <a:cxnSpLocks/>
            <a:stCxn id="98" idx="1"/>
            <a:endCxn id="58" idx="3"/>
          </p:cNvCxnSpPr>
          <p:nvPr/>
        </p:nvCxnSpPr>
        <p:spPr>
          <a:xfrm flipH="1">
            <a:off x="2485938" y="1933302"/>
            <a:ext cx="822754" cy="1096401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箭头连接符 103">
            <a:extLst>
              <a:ext uri="{FF2B5EF4-FFF2-40B4-BE49-F238E27FC236}">
                <a16:creationId xmlns:a16="http://schemas.microsoft.com/office/drawing/2014/main" id="{8D7867DE-482D-45BC-BC54-52C6A24A0A45}"/>
              </a:ext>
            </a:extLst>
          </p:cNvPr>
          <p:cNvCxnSpPr>
            <a:cxnSpLocks/>
            <a:stCxn id="102" idx="1"/>
            <a:endCxn id="59" idx="3"/>
          </p:cNvCxnSpPr>
          <p:nvPr/>
        </p:nvCxnSpPr>
        <p:spPr>
          <a:xfrm flipH="1">
            <a:off x="2483956" y="2943139"/>
            <a:ext cx="792974" cy="360255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直接箭头连接符 104">
            <a:extLst>
              <a:ext uri="{FF2B5EF4-FFF2-40B4-BE49-F238E27FC236}">
                <a16:creationId xmlns:a16="http://schemas.microsoft.com/office/drawing/2014/main" id="{9B806C94-C823-4CED-AD56-4692C11C9794}"/>
              </a:ext>
            </a:extLst>
          </p:cNvPr>
          <p:cNvCxnSpPr>
            <a:cxnSpLocks/>
            <a:stCxn id="101" idx="1"/>
            <a:endCxn id="60" idx="3"/>
          </p:cNvCxnSpPr>
          <p:nvPr/>
        </p:nvCxnSpPr>
        <p:spPr>
          <a:xfrm flipH="1" flipV="1">
            <a:off x="2493111" y="3601804"/>
            <a:ext cx="807989" cy="278314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直接箭头连接符 105">
            <a:extLst>
              <a:ext uri="{FF2B5EF4-FFF2-40B4-BE49-F238E27FC236}">
                <a16:creationId xmlns:a16="http://schemas.microsoft.com/office/drawing/2014/main" id="{C6ADDF78-3029-4CCD-B859-C22554D04B19}"/>
              </a:ext>
            </a:extLst>
          </p:cNvPr>
          <p:cNvCxnSpPr>
            <a:cxnSpLocks/>
            <a:stCxn id="99" idx="1"/>
            <a:endCxn id="61" idx="3"/>
          </p:cNvCxnSpPr>
          <p:nvPr/>
        </p:nvCxnSpPr>
        <p:spPr>
          <a:xfrm flipH="1" flipV="1">
            <a:off x="2493111" y="3879005"/>
            <a:ext cx="848571" cy="899724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箭头连接符 106">
            <a:extLst>
              <a:ext uri="{FF2B5EF4-FFF2-40B4-BE49-F238E27FC236}">
                <a16:creationId xmlns:a16="http://schemas.microsoft.com/office/drawing/2014/main" id="{C6AB4466-0052-4F57-ACBD-F5F4185DE82C}"/>
              </a:ext>
            </a:extLst>
          </p:cNvPr>
          <p:cNvCxnSpPr>
            <a:cxnSpLocks/>
            <a:stCxn id="100" idx="1"/>
            <a:endCxn id="62" idx="3"/>
          </p:cNvCxnSpPr>
          <p:nvPr/>
        </p:nvCxnSpPr>
        <p:spPr>
          <a:xfrm flipH="1" flipV="1">
            <a:off x="2493111" y="4185401"/>
            <a:ext cx="724742" cy="1571486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矩形 119">
            <a:extLst>
              <a:ext uri="{FF2B5EF4-FFF2-40B4-BE49-F238E27FC236}">
                <a16:creationId xmlns:a16="http://schemas.microsoft.com/office/drawing/2014/main" id="{282162E6-86CD-4CE0-BDD4-95EAB704C63F}"/>
              </a:ext>
            </a:extLst>
          </p:cNvPr>
          <p:cNvSpPr/>
          <p:nvPr/>
        </p:nvSpPr>
        <p:spPr>
          <a:xfrm>
            <a:off x="3803383" y="1665242"/>
            <a:ext cx="1197958" cy="24622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1" name="矩形 120">
            <a:extLst>
              <a:ext uri="{FF2B5EF4-FFF2-40B4-BE49-F238E27FC236}">
                <a16:creationId xmlns:a16="http://schemas.microsoft.com/office/drawing/2014/main" id="{7FE5FCA5-A0C6-4060-B396-A9966BADC979}"/>
              </a:ext>
            </a:extLst>
          </p:cNvPr>
          <p:cNvSpPr/>
          <p:nvPr/>
        </p:nvSpPr>
        <p:spPr>
          <a:xfrm>
            <a:off x="3939786" y="2842796"/>
            <a:ext cx="1061555" cy="232607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0E633F7D-BF6C-4F20-BDD6-FB81530470A7}"/>
              </a:ext>
            </a:extLst>
          </p:cNvPr>
          <p:cNvSpPr/>
          <p:nvPr/>
        </p:nvSpPr>
        <p:spPr>
          <a:xfrm>
            <a:off x="3803383" y="3569199"/>
            <a:ext cx="1061555" cy="25865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E4E57A95-BC5D-4647-8E04-4F1FEAC0A8C4}"/>
              </a:ext>
            </a:extLst>
          </p:cNvPr>
          <p:cNvSpPr/>
          <p:nvPr/>
        </p:nvSpPr>
        <p:spPr>
          <a:xfrm>
            <a:off x="3939786" y="4622688"/>
            <a:ext cx="1061555" cy="232607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4" name="矩形 123">
            <a:extLst>
              <a:ext uri="{FF2B5EF4-FFF2-40B4-BE49-F238E27FC236}">
                <a16:creationId xmlns:a16="http://schemas.microsoft.com/office/drawing/2014/main" id="{9F1E35A7-5BD0-489D-8D3C-162B40D5B8D5}"/>
              </a:ext>
            </a:extLst>
          </p:cNvPr>
          <p:cNvSpPr/>
          <p:nvPr/>
        </p:nvSpPr>
        <p:spPr>
          <a:xfrm>
            <a:off x="3788434" y="5695453"/>
            <a:ext cx="1212907" cy="237564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4516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2</TotalTime>
  <Words>65</Words>
  <Application>Microsoft Office PowerPoint</Application>
  <PresentationFormat>自定义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 WQS</dc:creator>
  <cp:lastModifiedBy>qishan</cp:lastModifiedBy>
  <cp:revision>157</cp:revision>
  <dcterms:created xsi:type="dcterms:W3CDTF">2020-11-13T06:28:33Z</dcterms:created>
  <dcterms:modified xsi:type="dcterms:W3CDTF">2022-10-22T07:46:23Z</dcterms:modified>
</cp:coreProperties>
</file>